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118CDFFC-53C8-4F34-A954-FEB3C712165E}" v="4" dt="2023-07-28T21:51:08.951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96" autoAdjust="0"/>
    <p:restoredTop sz="94660"/>
  </p:normalViewPr>
  <p:slideViewPr>
    <p:cSldViewPr snapToGrid="0">
      <p:cViewPr varScale="1">
        <p:scale>
          <a:sx n="83" d="100"/>
          <a:sy n="83" d="100"/>
        </p:scale>
        <p:origin x="96" y="1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Jenna Coalson" userId="76c212ef97562457" providerId="LiveId" clId="{118CDFFC-53C8-4F34-A954-FEB3C712165E}"/>
    <pc:docChg chg="custSel modSld">
      <pc:chgData name="Jenna Coalson" userId="76c212ef97562457" providerId="LiveId" clId="{118CDFFC-53C8-4F34-A954-FEB3C712165E}" dt="2023-07-28T21:51:11.387" v="5" actId="1076"/>
      <pc:docMkLst>
        <pc:docMk/>
      </pc:docMkLst>
      <pc:sldChg chg="addSp delSp modSp mod delAnim">
        <pc:chgData name="Jenna Coalson" userId="76c212ef97562457" providerId="LiveId" clId="{118CDFFC-53C8-4F34-A954-FEB3C712165E}" dt="2023-07-28T21:51:11.387" v="5" actId="1076"/>
        <pc:sldMkLst>
          <pc:docMk/>
          <pc:sldMk cId="636427983" sldId="256"/>
        </pc:sldMkLst>
        <pc:spChg chg="del mod">
          <ac:chgData name="Jenna Coalson" userId="76c212ef97562457" providerId="LiveId" clId="{118CDFFC-53C8-4F34-A954-FEB3C712165E}" dt="2023-07-28T21:51:00.107" v="3" actId="478"/>
          <ac:spMkLst>
            <pc:docMk/>
            <pc:sldMk cId="636427983" sldId="256"/>
            <ac:spMk id="9" creationId="{BCE3E47E-F1DE-0BE5-A960-A86A2E8C5026}"/>
          </ac:spMkLst>
        </pc:spChg>
        <pc:grpChg chg="add mod">
          <ac:chgData name="Jenna Coalson" userId="76c212ef97562457" providerId="LiveId" clId="{118CDFFC-53C8-4F34-A954-FEB3C712165E}" dt="2023-07-28T21:51:11.387" v="5" actId="1076"/>
          <ac:grpSpMkLst>
            <pc:docMk/>
            <pc:sldMk cId="636427983" sldId="256"/>
            <ac:grpSpMk id="2" creationId="{E9586BE5-7E19-F843-734F-76A1FD797BC4}"/>
          </ac:grpSpMkLst>
        </pc:grpChg>
        <pc:grpChg chg="mod">
          <ac:chgData name="Jenna Coalson" userId="76c212ef97562457" providerId="LiveId" clId="{118CDFFC-53C8-4F34-A954-FEB3C712165E}" dt="2023-07-28T21:51:08.951" v="4" actId="164"/>
          <ac:grpSpMkLst>
            <pc:docMk/>
            <pc:sldMk cId="636427983" sldId="256"/>
            <ac:grpSpMk id="14" creationId="{7383EA42-3C59-1347-6A60-44EBA6D86242}"/>
          </ac:grpSpMkLst>
        </pc:grpChg>
        <pc:grpChg chg="mod">
          <ac:chgData name="Jenna Coalson" userId="76c212ef97562457" providerId="LiveId" clId="{118CDFFC-53C8-4F34-A954-FEB3C712165E}" dt="2023-07-28T21:51:08.951" v="4" actId="164"/>
          <ac:grpSpMkLst>
            <pc:docMk/>
            <pc:sldMk cId="636427983" sldId="256"/>
            <ac:grpSpMk id="16" creationId="{B5DC3E8F-E4BC-1317-0913-14712BF8BBC5}"/>
          </ac:grpSpMkLst>
        </pc:gr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B330F2E-9665-9B78-7DE4-3CC1C235871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6CAB55D-91E5-DB12-693B-356167E92E0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BBC95E5-B73B-4F6F-FD9E-57C6585A3E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26C8E3-E3F9-4354-BBFD-546AA2B3579A}" type="datetimeFigureOut">
              <a:rPr lang="en-US" smtClean="0"/>
              <a:t>7/2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A4AD374-916E-2C9E-E9A6-92FB271368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7196012-8909-D58F-F8E7-797F677319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1B4015-937D-44E9-80DB-8B1627B22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74542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1C4ABCE-2FF5-3854-0FB2-2268B82878A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28C2CB1-6218-4A7A-94E5-F283B408DC7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9AD1CB7-BF9B-5FD5-2CFE-4AD06CBF6E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26C8E3-E3F9-4354-BBFD-546AA2B3579A}" type="datetimeFigureOut">
              <a:rPr lang="en-US" smtClean="0"/>
              <a:t>7/2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7DA4E39-964A-17DE-A599-4C541638ED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D01DF66-EAC9-3F3F-DE7E-E027D08D92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1B4015-937D-44E9-80DB-8B1627B22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21993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AFCED3D-EEB4-853C-359E-8286E9D4AE8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5911737-3F20-709E-94F1-A12D66A5A8D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08E7F67-6F00-BF6E-E312-517E2E5886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26C8E3-E3F9-4354-BBFD-546AA2B3579A}" type="datetimeFigureOut">
              <a:rPr lang="en-US" smtClean="0"/>
              <a:t>7/2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99E69F9-4AC5-4F63-96D0-80EAA2230E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4F6EE6F-6A61-5574-4F0C-937BD9D1A1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1B4015-937D-44E9-80DB-8B1627B22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53007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069A3A-24F4-146D-3BB9-0D012037D53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000E906-AFB7-6F54-2998-5E264839EF7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B6B761E-8446-EDD7-D5D7-F0D0750255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26C8E3-E3F9-4354-BBFD-546AA2B3579A}" type="datetimeFigureOut">
              <a:rPr lang="en-US" smtClean="0"/>
              <a:t>7/2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7ECAA4A-CE88-2EF2-C1D4-71B87A14A3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B3B2315-389C-27BA-13B7-226D73ED97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1B4015-937D-44E9-80DB-8B1627B22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93892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EE13449-F90D-EE59-F2CA-B345A1F7E6A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A9C1095-32E3-CB72-76B5-5A37DCE7E4D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C5338F9-8B2C-7574-E268-B167C30178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26C8E3-E3F9-4354-BBFD-546AA2B3579A}" type="datetimeFigureOut">
              <a:rPr lang="en-US" smtClean="0"/>
              <a:t>7/2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C9DD7B1-8271-82CA-2F6E-C4E36412D0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B7AED24-C492-966A-94F3-2F915207FB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1B4015-937D-44E9-80DB-8B1627B22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37942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D6A64A3-AD80-A0C9-EB8F-996057D455E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35B91F2-173A-D4C1-2525-05DAEB02987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AF82B12-E0E3-E101-A1B5-E53E49B6CC6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33E9CEA-EC0D-D444-E448-985D522B27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26C8E3-E3F9-4354-BBFD-546AA2B3579A}" type="datetimeFigureOut">
              <a:rPr lang="en-US" smtClean="0"/>
              <a:t>7/28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F6015CB-17F3-5BC5-0EDE-E1D9446493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7BC8385-784D-847F-8416-C58C3AC210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1B4015-937D-44E9-80DB-8B1627B22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00407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667E11A-D6A8-A0A3-1977-3704986C8DD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7F0BE7D-7734-4504-82F1-1D32E12279C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C7F041A-C07C-54C4-1CEA-F4AB16B6972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6C740D1-42B9-EB84-E2E9-213B73213FE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DF07F33-444E-509F-E9EC-D1E723F0EBF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018910B-7EDB-ED56-F910-7499E831A8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26C8E3-E3F9-4354-BBFD-546AA2B3579A}" type="datetimeFigureOut">
              <a:rPr lang="en-US" smtClean="0"/>
              <a:t>7/28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5A2D8B4-0C84-594E-9405-65A934E236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7690355-01AC-C0D8-C61F-86031471AA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1B4015-937D-44E9-80DB-8B1627B22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15738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81CB839-FE8E-35BE-72E0-60E3F141AE4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9DD77FE-37BE-C345-3D5F-DD4E97AABC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26C8E3-E3F9-4354-BBFD-546AA2B3579A}" type="datetimeFigureOut">
              <a:rPr lang="en-US" smtClean="0"/>
              <a:t>7/28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291AC12-1F19-F739-2370-168E2DE9BC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D7555BA-DBA1-BAAA-20C8-0F61DCA0BD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1B4015-937D-44E9-80DB-8B1627B22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70139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39FD058-2486-B1D6-10DE-04D6D40811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26C8E3-E3F9-4354-BBFD-546AA2B3579A}" type="datetimeFigureOut">
              <a:rPr lang="en-US" smtClean="0"/>
              <a:t>7/28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2CEAD7B-359E-88C6-ACE8-988B43EFEC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F45E3C8-1517-9115-9053-A9886204C2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1B4015-937D-44E9-80DB-8B1627B22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29403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4010BC7-F291-1C86-4482-BE57D7B76F9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3A7D7C1-BD53-57A9-FB95-8EEC0785474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584FFD2-1896-AE1F-00E3-D84616092CD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2C8B070-D434-9F42-3A38-99033BBD92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26C8E3-E3F9-4354-BBFD-546AA2B3579A}" type="datetimeFigureOut">
              <a:rPr lang="en-US" smtClean="0"/>
              <a:t>7/28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60FA358-7842-7AE5-3719-35F71B102E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50E4731-7000-F22E-A495-AB3AD1D5E2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1B4015-937D-44E9-80DB-8B1627B22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95595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621DB7-5D2D-6D60-065A-AEE7C92D748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37D976A-37C6-409C-BC89-6015AB3B24F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F6085D0-32C9-4AF6-F5F1-3C5E67E0BBF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07BFB24-FFD3-80D3-7B52-6014CDE13F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26C8E3-E3F9-4354-BBFD-546AA2B3579A}" type="datetimeFigureOut">
              <a:rPr lang="en-US" smtClean="0"/>
              <a:t>7/28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4CA9F90-4D58-A72F-38E5-93451CFBE1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0D4DEAE-B239-2C70-0115-89A0A12D33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1B4015-937D-44E9-80DB-8B1627B22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63671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B6E3DDB-CBE1-AB0D-C7CC-CA82565C32D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662DDBD-11C9-D68D-95FE-0A98A079539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E67B2AD-7045-9D25-6390-7CE0ACE3C4A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26C8E3-E3F9-4354-BBFD-546AA2B3579A}" type="datetimeFigureOut">
              <a:rPr lang="en-US" smtClean="0"/>
              <a:t>7/2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9F43291-056E-DC14-0481-674EB0DCEDE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9C141ED-1904-BFB6-BFBB-60847AC5ABA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1B4015-937D-44E9-80DB-8B1627B22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21489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E9586BE5-7E19-F843-734F-76A1FD797BC4}"/>
              </a:ext>
            </a:extLst>
          </p:cNvPr>
          <p:cNvGrpSpPr/>
          <p:nvPr/>
        </p:nvGrpSpPr>
        <p:grpSpPr>
          <a:xfrm>
            <a:off x="501758" y="841839"/>
            <a:ext cx="10986335" cy="3711148"/>
            <a:chOff x="189241" y="2543318"/>
            <a:chExt cx="10986335" cy="3711148"/>
          </a:xfrm>
        </p:grpSpPr>
        <p:grpSp>
          <p:nvGrpSpPr>
            <p:cNvPr id="16" name="Group 15">
              <a:extLst>
                <a:ext uri="{FF2B5EF4-FFF2-40B4-BE49-F238E27FC236}">
                  <a16:creationId xmlns:a16="http://schemas.microsoft.com/office/drawing/2014/main" id="{B5DC3E8F-E4BC-1317-0913-14712BF8BBC5}"/>
                </a:ext>
              </a:extLst>
            </p:cNvPr>
            <p:cNvGrpSpPr/>
            <p:nvPr/>
          </p:nvGrpSpPr>
          <p:grpSpPr>
            <a:xfrm>
              <a:off x="189241" y="2543318"/>
              <a:ext cx="5396801" cy="3711148"/>
              <a:chOff x="189241" y="2543318"/>
              <a:chExt cx="5396801" cy="3711148"/>
            </a:xfrm>
          </p:grpSpPr>
          <p:grpSp>
            <p:nvGrpSpPr>
              <p:cNvPr id="15" name="Group 14">
                <a:extLst>
                  <a:ext uri="{FF2B5EF4-FFF2-40B4-BE49-F238E27FC236}">
                    <a16:creationId xmlns:a16="http://schemas.microsoft.com/office/drawing/2014/main" id="{AC69AB3B-B7E6-961E-36FC-E5137D244CF1}"/>
                  </a:ext>
                </a:extLst>
              </p:cNvPr>
              <p:cNvGrpSpPr/>
              <p:nvPr/>
            </p:nvGrpSpPr>
            <p:grpSpPr>
              <a:xfrm>
                <a:off x="322176" y="2638425"/>
                <a:ext cx="5263866" cy="3616041"/>
                <a:chOff x="322176" y="2638425"/>
                <a:chExt cx="5263866" cy="3616041"/>
              </a:xfrm>
            </p:grpSpPr>
            <p:grpSp>
              <p:nvGrpSpPr>
                <p:cNvPr id="5" name="Group 4">
                  <a:extLst>
                    <a:ext uri="{FF2B5EF4-FFF2-40B4-BE49-F238E27FC236}">
                      <a16:creationId xmlns:a16="http://schemas.microsoft.com/office/drawing/2014/main" id="{6F35B299-43AC-635A-66B6-A3AB713628ED}"/>
                    </a:ext>
                  </a:extLst>
                </p:cNvPr>
                <p:cNvGrpSpPr/>
                <p:nvPr/>
              </p:nvGrpSpPr>
              <p:grpSpPr>
                <a:xfrm>
                  <a:off x="599175" y="2638425"/>
                  <a:ext cx="4986867" cy="3616041"/>
                  <a:chOff x="440266" y="2396067"/>
                  <a:chExt cx="4986867" cy="3616041"/>
                </a:xfrm>
              </p:grpSpPr>
              <p:pic>
                <p:nvPicPr>
                  <p:cNvPr id="6" name="Picture 5">
                    <a:extLst>
                      <a:ext uri="{FF2B5EF4-FFF2-40B4-BE49-F238E27FC236}">
                        <a16:creationId xmlns:a16="http://schemas.microsoft.com/office/drawing/2014/main" id="{55FE673F-FD0A-9AA1-07E3-9AD4E4F4FA1C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2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5072" t="5748" r="1444" b="10794"/>
                  <a:stretch/>
                </p:blipFill>
                <p:spPr>
                  <a:xfrm>
                    <a:off x="440266" y="2396067"/>
                    <a:ext cx="4986867" cy="3339042"/>
                  </a:xfrm>
                  <a:prstGeom prst="rect">
                    <a:avLst/>
                  </a:prstGeom>
                </p:spPr>
              </p:pic>
              <p:sp>
                <p:nvSpPr>
                  <p:cNvPr id="7" name="TextBox 6">
                    <a:extLst>
                      <a:ext uri="{FF2B5EF4-FFF2-40B4-BE49-F238E27FC236}">
                        <a16:creationId xmlns:a16="http://schemas.microsoft.com/office/drawing/2014/main" id="{D033F63D-1A17-6DEF-23E2-F43ED8E98FBB}"/>
                      </a:ext>
                    </a:extLst>
                  </p:cNvPr>
                  <p:cNvSpPr txBox="1"/>
                  <p:nvPr/>
                </p:nvSpPr>
                <p:spPr>
                  <a:xfrm>
                    <a:off x="1664231" y="5735109"/>
                    <a:ext cx="2517367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200" dirty="0">
                        <a:solidFill>
                          <a:schemeClr val="tx1">
                            <a:lumMod val="65000"/>
                            <a:lumOff val="35000"/>
                          </a:schemeClr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Rainfall (total mm previous month)</a:t>
                    </a:r>
                  </a:p>
                </p:txBody>
              </p:sp>
            </p:grpSp>
            <p:sp>
              <p:nvSpPr>
                <p:cNvPr id="10" name="TextBox 9">
                  <a:extLst>
                    <a:ext uri="{FF2B5EF4-FFF2-40B4-BE49-F238E27FC236}">
                      <a16:creationId xmlns:a16="http://schemas.microsoft.com/office/drawing/2014/main" id="{7D2408D1-82CA-E860-A3CB-A01DD983E0F2}"/>
                    </a:ext>
                  </a:extLst>
                </p:cNvPr>
                <p:cNvSpPr txBox="1"/>
                <p:nvPr/>
              </p:nvSpPr>
              <p:spPr>
                <a:xfrm rot="16200000">
                  <a:off x="-947514" y="4043840"/>
                  <a:ext cx="2816379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Probability of </a:t>
                  </a:r>
                  <a:r>
                    <a:rPr lang="en-US" sz="1200" i="1" dirty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Ae. aegypti </a:t>
                  </a:r>
                  <a:r>
                    <a:rPr lang="en-US" sz="1200" dirty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presence</a:t>
                  </a:r>
                </a:p>
              </p:txBody>
            </p:sp>
          </p:grpSp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CA86AA3F-B085-74F7-1597-39C5AD5BCC59}"/>
                  </a:ext>
                </a:extLst>
              </p:cNvPr>
              <p:cNvSpPr txBox="1"/>
              <p:nvPr/>
            </p:nvSpPr>
            <p:spPr>
              <a:xfrm>
                <a:off x="189241" y="2543318"/>
                <a:ext cx="409934" cy="461665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2400" b="1" dirty="0"/>
                  <a:t>A</a:t>
                </a:r>
              </a:p>
            </p:txBody>
          </p:sp>
        </p:grpSp>
        <p:grpSp>
          <p:nvGrpSpPr>
            <p:cNvPr id="14" name="Group 13">
              <a:extLst>
                <a:ext uri="{FF2B5EF4-FFF2-40B4-BE49-F238E27FC236}">
                  <a16:creationId xmlns:a16="http://schemas.microsoft.com/office/drawing/2014/main" id="{7383EA42-3C59-1347-6A60-44EBA6D86242}"/>
                </a:ext>
              </a:extLst>
            </p:cNvPr>
            <p:cNvGrpSpPr/>
            <p:nvPr/>
          </p:nvGrpSpPr>
          <p:grpSpPr>
            <a:xfrm>
              <a:off x="5675955" y="2543318"/>
              <a:ext cx="5499621" cy="3697978"/>
              <a:chOff x="5675955" y="2543318"/>
              <a:chExt cx="5499621" cy="3697978"/>
            </a:xfrm>
          </p:grpSpPr>
          <p:pic>
            <p:nvPicPr>
              <p:cNvPr id="4" name="Content Placeholder 4">
                <a:extLst>
                  <a:ext uri="{FF2B5EF4-FFF2-40B4-BE49-F238E27FC236}">
                    <a16:creationId xmlns:a16="http://schemas.microsoft.com/office/drawing/2014/main" id="{E46613CC-CA80-C65C-B2A9-A8CF3B705E5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425" t="6383" r="614" b="11084"/>
              <a:stretch/>
            </p:blipFill>
            <p:spPr>
              <a:xfrm>
                <a:off x="6163309" y="2675466"/>
                <a:ext cx="5012267" cy="3302000"/>
              </a:xfrm>
              <a:prstGeom prst="rect">
                <a:avLst/>
              </a:prstGeom>
            </p:spPr>
          </p:pic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F4B5DB83-E910-4BCD-F563-3B147CB1952D}"/>
                  </a:ext>
                </a:extLst>
              </p:cNvPr>
              <p:cNvSpPr txBox="1"/>
              <p:nvPr/>
            </p:nvSpPr>
            <p:spPr>
              <a:xfrm>
                <a:off x="7152373" y="5964297"/>
                <a:ext cx="333215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emperature (avg. in °C for  previous month)</a:t>
                </a:r>
              </a:p>
            </p:txBody>
          </p: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9B3008F8-6E90-6E04-71B0-8A7247DAE157}"/>
                  </a:ext>
                </a:extLst>
              </p:cNvPr>
              <p:cNvSpPr txBox="1"/>
              <p:nvPr/>
            </p:nvSpPr>
            <p:spPr>
              <a:xfrm>
                <a:off x="5675955" y="2543318"/>
                <a:ext cx="409934" cy="461665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2400" b="1" dirty="0"/>
                  <a:t>B</a:t>
                </a:r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A8560430-D76D-F6BA-1A29-AB1C2E6FA0FD}"/>
                  </a:ext>
                </a:extLst>
              </p:cNvPr>
              <p:cNvSpPr txBox="1"/>
              <p:nvPr/>
            </p:nvSpPr>
            <p:spPr>
              <a:xfrm rot="16200000">
                <a:off x="4534462" y="4043840"/>
                <a:ext cx="281637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robability of </a:t>
                </a:r>
                <a:r>
                  <a:rPr lang="en-US" sz="1200" i="1" dirty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e. aegypti </a:t>
                </a:r>
                <a:r>
                  <a:rPr lang="en-US" sz="1200" dirty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resence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6364279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</TotalTime>
  <Words>32</Words>
  <Application>Microsoft Office PowerPoint</Application>
  <PresentationFormat>Widescreen</PresentationFormat>
  <Paragraphs>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enna Coalson</dc:creator>
  <cp:lastModifiedBy>Jenna Coalson</cp:lastModifiedBy>
  <cp:revision>1</cp:revision>
  <dcterms:created xsi:type="dcterms:W3CDTF">2023-07-28T19:07:25Z</dcterms:created>
  <dcterms:modified xsi:type="dcterms:W3CDTF">2023-07-28T21:51:13Z</dcterms:modified>
</cp:coreProperties>
</file>